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6"/>
  </p:notesMasterIdLst>
  <p:sldIdLst>
    <p:sldId id="257" r:id="rId5"/>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7A15C2A1-16CB-488E-9130-09470BCF1913}" v="6" dt="2024-11-07T02:12:56.16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7025" autoAdjust="0"/>
    <p:restoredTop sz="94660"/>
  </p:normalViewPr>
  <p:slideViewPr>
    <p:cSldViewPr snapToGrid="0">
      <p:cViewPr>
        <p:scale>
          <a:sx n="51" d="100"/>
          <a:sy n="51" d="100"/>
        </p:scale>
        <p:origin x="2562" y="54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presProps" Target="presProps.xml"/><Relationship Id="rId12" Type="http://schemas.microsoft.com/office/2015/10/relationships/revisionInfo" Target="revisionInfo.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notesMaster" Target="notesMasters/notesMaster1.xml"/><Relationship Id="rId11" Type="http://schemas.microsoft.com/office/2016/11/relationships/changesInfo" Target="changesInfos/changesInfo1.xml"/><Relationship Id="rId5" Type="http://schemas.openxmlformats.org/officeDocument/2006/relationships/slide" Target="slides/slide1.xml"/><Relationship Id="rId10"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西浦　颯" userId="30eb12cf-a0f0-479c-babe-56a40fd49a1c" providerId="ADAL" clId="{7A15C2A1-16CB-488E-9130-09470BCF1913}"/>
    <pc:docChg chg="undo custSel modSld">
      <pc:chgData name="西浦　颯" userId="30eb12cf-a0f0-479c-babe-56a40fd49a1c" providerId="ADAL" clId="{7A15C2A1-16CB-488E-9130-09470BCF1913}" dt="2024-11-07T02:15:11.137" v="55" actId="1036"/>
      <pc:docMkLst>
        <pc:docMk/>
      </pc:docMkLst>
      <pc:sldChg chg="addSp delSp modSp mod">
        <pc:chgData name="西浦　颯" userId="30eb12cf-a0f0-479c-babe-56a40fd49a1c" providerId="ADAL" clId="{7A15C2A1-16CB-488E-9130-09470BCF1913}" dt="2024-11-07T02:15:11.137" v="55" actId="1036"/>
        <pc:sldMkLst>
          <pc:docMk/>
          <pc:sldMk cId="1141553524" sldId="257"/>
        </pc:sldMkLst>
        <pc:spChg chg="mod">
          <ac:chgData name="西浦　颯" userId="30eb12cf-a0f0-479c-babe-56a40fd49a1c" providerId="ADAL" clId="{7A15C2A1-16CB-488E-9130-09470BCF1913}" dt="2024-11-07T02:15:11.137" v="55" actId="1036"/>
          <ac:spMkLst>
            <pc:docMk/>
            <pc:sldMk cId="1141553524" sldId="257"/>
            <ac:spMk id="9" creationId="{A3C727B8-4320-CC27-89DB-A9BCC25EA2A5}"/>
          </ac:spMkLst>
        </pc:spChg>
        <pc:spChg chg="mod topLvl">
          <ac:chgData name="西浦　颯" userId="30eb12cf-a0f0-479c-babe-56a40fd49a1c" providerId="ADAL" clId="{7A15C2A1-16CB-488E-9130-09470BCF1913}" dt="2024-11-07T02:12:07.154" v="33" actId="164"/>
          <ac:spMkLst>
            <pc:docMk/>
            <pc:sldMk cId="1141553524" sldId="257"/>
            <ac:spMk id="14" creationId="{855342EB-64D8-7DCB-DFD1-E0E1FD8AB75D}"/>
          </ac:spMkLst>
        </pc:spChg>
        <pc:spChg chg="mod topLvl">
          <ac:chgData name="西浦　颯" userId="30eb12cf-a0f0-479c-babe-56a40fd49a1c" providerId="ADAL" clId="{7A15C2A1-16CB-488E-9130-09470BCF1913}" dt="2024-11-07T02:12:07.154" v="33" actId="164"/>
          <ac:spMkLst>
            <pc:docMk/>
            <pc:sldMk cId="1141553524" sldId="257"/>
            <ac:spMk id="15" creationId="{847E47CC-3553-BE05-7E15-71FDF48569FE}"/>
          </ac:spMkLst>
        </pc:spChg>
        <pc:spChg chg="mod topLvl">
          <ac:chgData name="西浦　颯" userId="30eb12cf-a0f0-479c-babe-56a40fd49a1c" providerId="ADAL" clId="{7A15C2A1-16CB-488E-9130-09470BCF1913}" dt="2024-11-07T02:12:07.154" v="33" actId="164"/>
          <ac:spMkLst>
            <pc:docMk/>
            <pc:sldMk cId="1141553524" sldId="257"/>
            <ac:spMk id="16" creationId="{B80A8EEC-2FC1-1F10-9A81-12AA03124FF4}"/>
          </ac:spMkLst>
        </pc:spChg>
        <pc:spChg chg="mod topLvl">
          <ac:chgData name="西浦　颯" userId="30eb12cf-a0f0-479c-babe-56a40fd49a1c" providerId="ADAL" clId="{7A15C2A1-16CB-488E-9130-09470BCF1913}" dt="2024-11-07T02:12:07.154" v="33" actId="164"/>
          <ac:spMkLst>
            <pc:docMk/>
            <pc:sldMk cId="1141553524" sldId="257"/>
            <ac:spMk id="17" creationId="{DBEE4DE0-7080-B535-4D56-70AFDD975CB2}"/>
          </ac:spMkLst>
        </pc:spChg>
        <pc:spChg chg="del">
          <ac:chgData name="西浦　颯" userId="30eb12cf-a0f0-479c-babe-56a40fd49a1c" providerId="ADAL" clId="{7A15C2A1-16CB-488E-9130-09470BCF1913}" dt="2024-11-07T02:09:50.010" v="2" actId="478"/>
          <ac:spMkLst>
            <pc:docMk/>
            <pc:sldMk cId="1141553524" sldId="257"/>
            <ac:spMk id="18" creationId="{9581F88B-AE19-0334-B92C-A1F8EF5573D4}"/>
          </ac:spMkLst>
        </pc:spChg>
        <pc:spChg chg="del mod topLvl">
          <ac:chgData name="西浦　颯" userId="30eb12cf-a0f0-479c-babe-56a40fd49a1c" providerId="ADAL" clId="{7A15C2A1-16CB-488E-9130-09470BCF1913}" dt="2024-11-07T02:10:44.632" v="14" actId="478"/>
          <ac:spMkLst>
            <pc:docMk/>
            <pc:sldMk cId="1141553524" sldId="257"/>
            <ac:spMk id="19" creationId="{EB880BCF-075E-1795-9516-CB6F611B10DC}"/>
          </ac:spMkLst>
        </pc:spChg>
        <pc:spChg chg="del mod topLvl">
          <ac:chgData name="西浦　颯" userId="30eb12cf-a0f0-479c-babe-56a40fd49a1c" providerId="ADAL" clId="{7A15C2A1-16CB-488E-9130-09470BCF1913}" dt="2024-11-07T02:10:39.669" v="11" actId="478"/>
          <ac:spMkLst>
            <pc:docMk/>
            <pc:sldMk cId="1141553524" sldId="257"/>
            <ac:spMk id="20" creationId="{BFC7CBD8-709A-38CB-3755-F3137C276FCF}"/>
          </ac:spMkLst>
        </pc:spChg>
        <pc:spChg chg="del mod topLvl">
          <ac:chgData name="西浦　颯" userId="30eb12cf-a0f0-479c-babe-56a40fd49a1c" providerId="ADAL" clId="{7A15C2A1-16CB-488E-9130-09470BCF1913}" dt="2024-11-07T02:10:38.389" v="10" actId="478"/>
          <ac:spMkLst>
            <pc:docMk/>
            <pc:sldMk cId="1141553524" sldId="257"/>
            <ac:spMk id="21" creationId="{88F709BD-8F90-6F17-B214-61802F8B1299}"/>
          </ac:spMkLst>
        </pc:spChg>
        <pc:spChg chg="del mod topLvl">
          <ac:chgData name="西浦　颯" userId="30eb12cf-a0f0-479c-babe-56a40fd49a1c" providerId="ADAL" clId="{7A15C2A1-16CB-488E-9130-09470BCF1913}" dt="2024-11-07T02:10:46.181" v="15" actId="478"/>
          <ac:spMkLst>
            <pc:docMk/>
            <pc:sldMk cId="1141553524" sldId="257"/>
            <ac:spMk id="22" creationId="{0EB4E56A-B88B-6F1B-1C37-4B6F789D98EF}"/>
          </ac:spMkLst>
        </pc:spChg>
        <pc:spChg chg="del">
          <ac:chgData name="西浦　颯" userId="30eb12cf-a0f0-479c-babe-56a40fd49a1c" providerId="ADAL" clId="{7A15C2A1-16CB-488E-9130-09470BCF1913}" dt="2024-11-07T02:10:17.905" v="6" actId="478"/>
          <ac:spMkLst>
            <pc:docMk/>
            <pc:sldMk cId="1141553524" sldId="257"/>
            <ac:spMk id="23" creationId="{D2ECBAC3-1AD4-C99A-60B2-EE861E16A434}"/>
          </ac:spMkLst>
        </pc:spChg>
        <pc:spChg chg="del mod topLvl">
          <ac:chgData name="西浦　颯" userId="30eb12cf-a0f0-479c-babe-56a40fd49a1c" providerId="ADAL" clId="{7A15C2A1-16CB-488E-9130-09470BCF1913}" dt="2024-11-07T02:10:48.182" v="16" actId="478"/>
          <ac:spMkLst>
            <pc:docMk/>
            <pc:sldMk cId="1141553524" sldId="257"/>
            <ac:spMk id="24" creationId="{C8105161-0201-6397-29D3-48398C15EDF5}"/>
          </ac:spMkLst>
        </pc:spChg>
        <pc:spChg chg="del">
          <ac:chgData name="西浦　颯" userId="30eb12cf-a0f0-479c-babe-56a40fd49a1c" providerId="ADAL" clId="{7A15C2A1-16CB-488E-9130-09470BCF1913}" dt="2024-11-07T02:10:15.704" v="5" actId="478"/>
          <ac:spMkLst>
            <pc:docMk/>
            <pc:sldMk cId="1141553524" sldId="257"/>
            <ac:spMk id="25" creationId="{0135F709-02D7-A335-9A97-FFA00483C2DE}"/>
          </ac:spMkLst>
        </pc:spChg>
        <pc:grpChg chg="add del mod">
          <ac:chgData name="西浦　颯" userId="30eb12cf-a0f0-479c-babe-56a40fd49a1c" providerId="ADAL" clId="{7A15C2A1-16CB-488E-9130-09470BCF1913}" dt="2024-11-07T02:13:03.230" v="41" actId="478"/>
          <ac:grpSpMkLst>
            <pc:docMk/>
            <pc:sldMk cId="1141553524" sldId="257"/>
            <ac:grpSpMk id="2" creationId="{93D893F3-6EE4-D415-7D98-2EBDAFFCC875}"/>
          </ac:grpSpMkLst>
        </pc:grpChg>
        <pc:grpChg chg="del">
          <ac:chgData name="西浦　颯" userId="30eb12cf-a0f0-479c-babe-56a40fd49a1c" providerId="ADAL" clId="{7A15C2A1-16CB-488E-9130-09470BCF1913}" dt="2024-11-07T02:10:36.831" v="9" actId="165"/>
          <ac:grpSpMkLst>
            <pc:docMk/>
            <pc:sldMk cId="1141553524" sldId="257"/>
            <ac:grpSpMk id="26" creationId="{E3344D2C-A38B-0EA6-04A5-60806120288D}"/>
          </ac:grpSpMkLst>
        </pc:grpChg>
        <pc:picChg chg="add mod">
          <ac:chgData name="西浦　颯" userId="30eb12cf-a0f0-479c-babe-56a40fd49a1c" providerId="ADAL" clId="{7A15C2A1-16CB-488E-9130-09470BCF1913}" dt="2024-11-07T02:15:11.137" v="55" actId="1036"/>
          <ac:picMkLst>
            <pc:docMk/>
            <pc:sldMk cId="1141553524" sldId="257"/>
            <ac:picMk id="4" creationId="{B86DBD14-2B6D-2CED-C401-4E0C408817C1}"/>
          </ac:picMkLst>
        </pc:picChg>
        <pc:picChg chg="mod topLvl">
          <ac:chgData name="西浦　颯" userId="30eb12cf-a0f0-479c-babe-56a40fd49a1c" providerId="ADAL" clId="{7A15C2A1-16CB-488E-9130-09470BCF1913}" dt="2024-11-07T02:12:07.154" v="33" actId="164"/>
          <ac:picMkLst>
            <pc:docMk/>
            <pc:sldMk cId="1141553524" sldId="257"/>
            <ac:picMk id="7" creationId="{91056798-A898-43E1-F6EA-AC64442AE3B4}"/>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982614E-75D0-4A2E-9473-469482056D6A}" type="datetimeFigureOut">
              <a:rPr kumimoji="1" lang="ja-JP" altLang="en-US" smtClean="0"/>
              <a:t>2024/11/7</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41347C2-F46F-428D-8EAC-E2703157A7F1}" type="slidenum">
              <a:rPr kumimoji="1" lang="ja-JP" altLang="en-US" smtClean="0"/>
              <a:t>‹#›</a:t>
            </a:fld>
            <a:endParaRPr kumimoji="1" lang="ja-JP" altLang="en-US"/>
          </a:p>
        </p:txBody>
      </p:sp>
    </p:spTree>
    <p:extLst>
      <p:ext uri="{BB962C8B-B14F-4D97-AF65-F5344CB8AC3E}">
        <p14:creationId xmlns:p14="http://schemas.microsoft.com/office/powerpoint/2010/main" val="189770054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38136185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27660684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36260722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31495025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404255556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40763734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16857581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995991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252601982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32750264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8000F9E-9E0A-4881-9B2D-BC3CA2A1F61B}" type="datetimeFigureOut">
              <a:rPr kumimoji="1" lang="ja-JP" altLang="en-US" smtClean="0"/>
              <a:t>2024/1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358461489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000F9E-9E0A-4881-9B2D-BC3CA2A1F61B}" type="datetimeFigureOut">
              <a:rPr kumimoji="1" lang="ja-JP" altLang="en-US" smtClean="0"/>
              <a:t>2024/11/7</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1BE2AD-841C-4C0F-BA18-5F0A5E43C41B}" type="slidenum">
              <a:rPr kumimoji="1" lang="ja-JP" altLang="en-US" smtClean="0"/>
              <a:t>‹#›</a:t>
            </a:fld>
            <a:endParaRPr kumimoji="1" lang="ja-JP" altLang="en-US"/>
          </a:p>
        </p:txBody>
      </p:sp>
    </p:spTree>
    <p:extLst>
      <p:ext uri="{BB962C8B-B14F-4D97-AF65-F5344CB8AC3E}">
        <p14:creationId xmlns:p14="http://schemas.microsoft.com/office/powerpoint/2010/main" val="208752935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テキスト ボックス 8">
            <a:extLst>
              <a:ext uri="{FF2B5EF4-FFF2-40B4-BE49-F238E27FC236}">
                <a16:creationId xmlns:a16="http://schemas.microsoft.com/office/drawing/2014/main" id="{A3C727B8-4320-CC27-89DB-A9BCC25EA2A5}"/>
              </a:ext>
            </a:extLst>
          </p:cNvPr>
          <p:cNvSpPr txBox="1"/>
          <p:nvPr/>
        </p:nvSpPr>
        <p:spPr>
          <a:xfrm>
            <a:off x="315982" y="4627844"/>
            <a:ext cx="8512036" cy="1277273"/>
          </a:xfrm>
          <a:prstGeom prst="rect">
            <a:avLst/>
          </a:prstGeom>
          <a:noFill/>
        </p:spPr>
        <p:txBody>
          <a:bodyPr wrap="square">
            <a:spAutoFit/>
          </a:bodyPr>
          <a:lstStyle/>
          <a:p>
            <a:pPr marL="0" marR="0" lvl="0" indent="0" algn="just" defTabSz="457200" rtl="0" eaLnBrk="1" fontAlgn="auto" latinLnBrk="0" hangingPunct="1">
              <a:lnSpc>
                <a:spcPct val="100000"/>
              </a:lnSpc>
              <a:spcBef>
                <a:spcPts val="0"/>
              </a:spcBef>
              <a:spcAft>
                <a:spcPts val="0"/>
              </a:spcAft>
              <a:buClrTx/>
              <a:buSzTx/>
              <a:buFontTx/>
              <a:buNone/>
              <a:tabLst/>
              <a:defRPr/>
            </a:pPr>
            <a:r>
              <a:rPr kumimoji="1" lang="en-US" altLang="ja-JP" sz="1100" b="1"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Figure S4. </a:t>
            </a:r>
            <a:r>
              <a:rPr kumimoji="1" lang="en-US" altLang="ja-JP"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Histological and immunohistochemical findings in chickens inoculated 10</a:t>
            </a:r>
            <a:r>
              <a:rPr kumimoji="1" lang="en-US" altLang="ja-JP" sz="1100" b="0" i="0" u="none" strike="noStrike" kern="1200" cap="none" spc="0" normalizeH="0" baseline="3000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6</a:t>
            </a:r>
            <a:r>
              <a:rPr kumimoji="1" lang="en-US" altLang="ja-JP"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 EID</a:t>
            </a:r>
            <a:r>
              <a:rPr kumimoji="1" lang="en-US" altLang="ja-JP" sz="1100" b="0" i="0" u="none" strike="noStrike" kern="1200" cap="none" spc="0" normalizeH="0" baseline="-2500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50</a:t>
            </a:r>
            <a:r>
              <a:rPr kumimoji="1" lang="en-US" altLang="ja-JP"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 </a:t>
            </a:r>
            <a:r>
              <a:rPr kumimoji="1" lang="en-US" altLang="ja-JP" sz="1100" dirty="0">
                <a:solidFill>
                  <a:srgbClr val="191919"/>
                </a:solidFill>
                <a:latin typeface="Palatino Linotype" panose="02040502050505030304" pitchFamily="18" charset="0"/>
                <a:ea typeface="ＭＳ Ｐゴシック" panose="020B0600070205080204" pitchFamily="50" charset="-128"/>
                <a:cs typeface="Times New Roman" panose="02020603050405020304" pitchFamily="18" charset="0"/>
              </a:rPr>
              <a:t>Kagoshima</a:t>
            </a:r>
            <a:r>
              <a:rPr kumimoji="1" lang="en-US" altLang="ja-JP"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23B1T. (a) Lung, respiratory lobules</a:t>
            </a:r>
            <a:r>
              <a:rPr kumimoji="1" lang="en-US" altLang="ja-JP" sz="1100" dirty="0">
                <a:solidFill>
                  <a:srgbClr val="191919"/>
                </a:solidFill>
                <a:latin typeface="Palatino Linotype" panose="02040502050505030304" pitchFamily="18" charset="0"/>
                <a:ea typeface="ＭＳ Ｐゴシック" panose="020B0600070205080204" pitchFamily="50" charset="-128"/>
                <a:cs typeface="Times New Roman" panose="02020603050405020304" pitchFamily="18" charset="0"/>
              </a:rPr>
              <a:t>, Interstitial pneumonia</a:t>
            </a:r>
            <a:r>
              <a:rPr kumimoji="1" lang="en-US" altLang="ja-JP"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rPr>
              <a:t>. Hematoxylin and eosin (HE). (b) Spleen. Necrosis of ellipsoid with fibrinous exudation. HE. (c) Cerebrum. Focal necrosis of neurons and glial cells. HE. (d) Pancreas. Focal necrosis of acinar cells. HE. (e) Lung, respiratory lobules. Strong intranuclear immunohistochemical signals were found in air capillaries. Immunolabeling for Influenza A virus. (f) Spleen. There is positive nuclear and cytoplasmic staining of ellipsoidal cells. Immunolabeling for Influenza A virus. (g) Cerebrum. Nuclei and dendrites of neurons are positive for Influenza A virus. Immunolabeling for Influenza A virus. (h) Pancreas. Nuclear immunoreactivity in necrotic acinar cells. Influenza A virus.</a:t>
            </a:r>
            <a:endParaRPr kumimoji="1" lang="ja-JP" altLang="en-US" sz="1100" b="0" i="0" u="none" strike="noStrike" kern="1200" cap="none" spc="0" normalizeH="0" baseline="0" noProof="0" dirty="0">
              <a:ln>
                <a:noFill/>
              </a:ln>
              <a:solidFill>
                <a:srgbClr val="191919"/>
              </a:solidFill>
              <a:effectLst/>
              <a:uLnTx/>
              <a:uFillTx/>
              <a:latin typeface="Palatino Linotype" panose="02040502050505030304" pitchFamily="18" charset="0"/>
              <a:ea typeface="ＭＳ Ｐゴシック" panose="020B0600070205080204" pitchFamily="50" charset="-128"/>
              <a:cs typeface="Times New Roman" panose="02020603050405020304" pitchFamily="18" charset="0"/>
            </a:endParaRPr>
          </a:p>
        </p:txBody>
      </p:sp>
      <p:pic>
        <p:nvPicPr>
          <p:cNvPr id="4" name="図 3" descr="背景パターン が含まれている画像&#10;&#10;自動的に生成された説明">
            <a:extLst>
              <a:ext uri="{FF2B5EF4-FFF2-40B4-BE49-F238E27FC236}">
                <a16:creationId xmlns:a16="http://schemas.microsoft.com/office/drawing/2014/main" id="{B86DBD14-2B6D-2CED-C401-4E0C408817C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6051" y="914255"/>
            <a:ext cx="8371898" cy="3678271"/>
          </a:xfrm>
          <a:prstGeom prst="rect">
            <a:avLst/>
          </a:prstGeom>
        </p:spPr>
      </p:pic>
    </p:spTree>
    <p:extLst>
      <p:ext uri="{BB962C8B-B14F-4D97-AF65-F5344CB8AC3E}">
        <p14:creationId xmlns:p14="http://schemas.microsoft.com/office/powerpoint/2010/main" val="114155352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ドキュメント" ma:contentTypeID="0x0101001B8E7EBA0EE0944D8A60476C5090323E" ma:contentTypeVersion="4" ma:contentTypeDescription="新しいドキュメントを作成します。" ma:contentTypeScope="" ma:versionID="8f557056da61e5fbe63d67920799e1b0">
  <xsd:schema xmlns:xsd="http://www.w3.org/2001/XMLSchema" xmlns:xs="http://www.w3.org/2001/XMLSchema" xmlns:p="http://schemas.microsoft.com/office/2006/metadata/properties" xmlns:ns2="1df211c6-8f17-4a6b-80d3-29c65b8a01a6" targetNamespace="http://schemas.microsoft.com/office/2006/metadata/properties" ma:root="true" ma:fieldsID="f7a617a5ca74d227a7193e56a5954a8e" ns2:_="">
    <xsd:import namespace="1df211c6-8f17-4a6b-80d3-29c65b8a01a6"/>
    <xsd:element name="properties">
      <xsd:complexType>
        <xsd:sequence>
          <xsd:element name="documentManagement">
            <xsd:complexType>
              <xsd:all>
                <xsd:element ref="ns2:MediaServiceMetadata" minOccurs="0"/>
                <xsd:element ref="ns2:MediaServiceFastMetadata" minOccurs="0"/>
                <xsd:element ref="ns2:MediaServiceSearchPropertie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df211c6-8f17-4a6b-80d3-29c65b8a01a6"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SearchProperties" ma:index="10" nillable="true" ma:displayName="MediaServiceSearchProperties" ma:hidden="true" ma:internalName="MediaServiceSearchProperties" ma:readOnly="true">
      <xsd:simpleType>
        <xsd:restriction base="dms:Note"/>
      </xsd:simpleType>
    </xsd:element>
    <xsd:element name="MediaServiceObjectDetectorVersions" ma:index="11" nillable="true" ma:displayName="MediaServiceObjectDetectorVersions" ma:hidden="true" ma:indexed="true" ma:internalName="MediaServiceObjectDetectorVersions"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5AE76185-A995-4929-843A-2D695F368B6B}">
  <ds:schemaRefs>
    <ds:schemaRef ds:uri="http://schemas.microsoft.com/office/2006/metadata/properties"/>
    <ds:schemaRef ds:uri="http://schemas.microsoft.com/office/infopath/2007/PartnerControls"/>
  </ds:schemaRefs>
</ds:datastoreItem>
</file>

<file path=customXml/itemProps2.xml><?xml version="1.0" encoding="utf-8"?>
<ds:datastoreItem xmlns:ds="http://schemas.openxmlformats.org/officeDocument/2006/customXml" ds:itemID="{3B96F21F-6D17-416F-AB26-36414936136D}">
  <ds:schemaRefs>
    <ds:schemaRef ds:uri="http://schemas.microsoft.com/sharepoint/v3/contenttype/forms"/>
  </ds:schemaRefs>
</ds:datastoreItem>
</file>

<file path=customXml/itemProps3.xml><?xml version="1.0" encoding="utf-8"?>
<ds:datastoreItem xmlns:ds="http://schemas.openxmlformats.org/officeDocument/2006/customXml" ds:itemID="{5D589503-2F5B-48D1-9AB0-4E59336872D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df211c6-8f17-4a6b-80d3-29c65b8a01a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emplate>Office 2013 - 2022 Theme</Template>
  <TotalTime>42</TotalTime>
  <Words>160</Words>
  <Application>Microsoft Office PowerPoint</Application>
  <PresentationFormat>画面に合わせる (4:3)</PresentationFormat>
  <Paragraphs>1</Paragraphs>
  <Slides>1</Slides>
  <Notes>0</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1</vt:i4>
      </vt:variant>
    </vt:vector>
  </HeadingPairs>
  <TitlesOfParts>
    <vt:vector size="7" baseType="lpstr">
      <vt:lpstr>游ゴシック</vt:lpstr>
      <vt:lpstr>Arial</vt:lpstr>
      <vt:lpstr>Calibri</vt:lpstr>
      <vt:lpstr>Calibri Light</vt:lpstr>
      <vt:lpstr>Palatino Linotype</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西浦 颯</dc:creator>
  <cp:lastModifiedBy>西浦 颯</cp:lastModifiedBy>
  <cp:revision>1</cp:revision>
  <dcterms:created xsi:type="dcterms:W3CDTF">2024-10-15T08:18:22Z</dcterms:created>
  <dcterms:modified xsi:type="dcterms:W3CDTF">2024-11-07T02:15:1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B8E7EBA0EE0944D8A60476C5090323E</vt:lpwstr>
  </property>
</Properties>
</file>